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8" d="100"/>
          <a:sy n="78" d="100"/>
        </p:scale>
        <p:origin x="-2670" y="-83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19535-7DD3-4FA5-9519-F80494509AE4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DBB081-9B68-4709-BBC6-F6A2A39D7C29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2" cstate="print"/>
          <a:srcRect b="8032"/>
          <a:stretch/>
        </p:blipFill>
        <p:spPr bwMode="auto">
          <a:xfrm>
            <a:off x="611560" y="697131"/>
            <a:ext cx="8064896" cy="2273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TextBox 1"/>
          <p:cNvSpPr txBox="1"/>
          <p:nvPr/>
        </p:nvSpPr>
        <p:spPr>
          <a:xfrm rot="16200000">
            <a:off x="679802" y="3228132"/>
            <a:ext cx="756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gains</a:t>
            </a:r>
            <a:endParaRPr lang="en-GB" sz="1000" b="1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884323" y="3107867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losses</a:t>
            </a:r>
            <a:endParaRPr lang="en-GB" sz="1000" b="1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1155030" y="3322013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No changes</a:t>
            </a:r>
            <a:endParaRPr lang="en-GB" sz="1000" b="1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1988309" y="3217008"/>
            <a:ext cx="756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gains</a:t>
            </a:r>
            <a:endParaRPr lang="en-GB" sz="1000" b="1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2192830" y="3323891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losses</a:t>
            </a:r>
            <a:endParaRPr lang="en-GB" sz="1000" b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2498676" y="3310889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No changes</a:t>
            </a:r>
            <a:endParaRPr lang="en-GB" sz="100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3321080" y="3205133"/>
            <a:ext cx="756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gains</a:t>
            </a:r>
            <a:endParaRPr lang="en-GB" sz="1000" b="1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3525601" y="3312016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losses</a:t>
            </a:r>
            <a:endParaRPr lang="en-GB" sz="1000" b="1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3831447" y="3299014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No changes</a:t>
            </a:r>
            <a:endParaRPr lang="en-GB" sz="1000" b="1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4676604" y="3205132"/>
            <a:ext cx="756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gains</a:t>
            </a:r>
            <a:endParaRPr lang="en-GB" sz="1000" b="1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4881125" y="3312015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losses</a:t>
            </a:r>
            <a:endParaRPr lang="en-GB" sz="1000" b="1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5186971" y="3299013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No changes</a:t>
            </a:r>
            <a:endParaRPr lang="en-GB" sz="1000" b="1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6021004" y="3198443"/>
            <a:ext cx="756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gains</a:t>
            </a:r>
            <a:endParaRPr lang="en-GB" sz="1000" b="1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6225525" y="3305326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losses</a:t>
            </a:r>
            <a:endParaRPr lang="en-GB" sz="1000" b="1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6531371" y="3292324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No changes</a:t>
            </a:r>
            <a:endParaRPr lang="en-GB" sz="1000" b="1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7377280" y="3203629"/>
            <a:ext cx="756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gains</a:t>
            </a:r>
            <a:endParaRPr lang="en-GB" sz="1000" b="1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7581801" y="3310512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losses</a:t>
            </a:r>
            <a:endParaRPr lang="en-GB" sz="1000" b="1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7887647" y="3297510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No changes</a:t>
            </a:r>
            <a:endParaRPr lang="en-GB" sz="10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849184" y="636999"/>
            <a:ext cx="97210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miR-17</a:t>
            </a:r>
            <a:endParaRPr lang="en-GB" sz="10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2195736" y="642937"/>
            <a:ext cx="97210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miR-20a</a:t>
            </a:r>
            <a:endParaRPr lang="en-GB" sz="10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3527883" y="625368"/>
            <a:ext cx="97210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miR-92a</a:t>
            </a:r>
            <a:endParaRPr lang="en-GB" sz="10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4896035" y="625123"/>
            <a:ext cx="97210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miR-19a</a:t>
            </a:r>
            <a:endParaRPr lang="en-GB" sz="10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6228184" y="625368"/>
            <a:ext cx="97210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miR-19b</a:t>
            </a:r>
            <a:endParaRPr lang="en-GB" sz="10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7596336" y="631061"/>
            <a:ext cx="97210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miR-18b</a:t>
            </a:r>
            <a:endParaRPr lang="en-GB" sz="1000" b="1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-57417" y="1654141"/>
            <a:ext cx="129614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err="1" smtClean="0"/>
              <a:t>miRNA</a:t>
            </a:r>
            <a:r>
              <a:rPr lang="en-GB" sz="1000" b="1" dirty="0" smtClean="0"/>
              <a:t> expression</a:t>
            </a:r>
            <a:endParaRPr lang="en-GB" sz="1000" b="1" dirty="0"/>
          </a:p>
        </p:txBody>
      </p:sp>
      <p:sp>
        <p:nvSpPr>
          <p:cNvPr id="3" name="Rectangle 2"/>
          <p:cNvSpPr/>
          <p:nvPr/>
        </p:nvSpPr>
        <p:spPr>
          <a:xfrm>
            <a:off x="1907704" y="1711932"/>
            <a:ext cx="144016" cy="8225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Rectangle 34"/>
          <p:cNvSpPr/>
          <p:nvPr/>
        </p:nvSpPr>
        <p:spPr>
          <a:xfrm>
            <a:off x="3240228" y="1639173"/>
            <a:ext cx="144016" cy="8225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Rectangle 35"/>
          <p:cNvSpPr/>
          <p:nvPr/>
        </p:nvSpPr>
        <p:spPr>
          <a:xfrm>
            <a:off x="4572000" y="1693367"/>
            <a:ext cx="144016" cy="8225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Rectangle 36"/>
          <p:cNvSpPr/>
          <p:nvPr/>
        </p:nvSpPr>
        <p:spPr>
          <a:xfrm>
            <a:off x="5934214" y="1705243"/>
            <a:ext cx="144016" cy="8225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/>
          <p:cNvSpPr/>
          <p:nvPr/>
        </p:nvSpPr>
        <p:spPr>
          <a:xfrm>
            <a:off x="7248172" y="1735685"/>
            <a:ext cx="144016" cy="8225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3" cstate="print"/>
          <a:srcRect r="50000" b="8417"/>
          <a:stretch/>
        </p:blipFill>
        <p:spPr bwMode="auto">
          <a:xfrm>
            <a:off x="611560" y="3973170"/>
            <a:ext cx="3733737" cy="22322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9" name="TextBox 38"/>
          <p:cNvSpPr txBox="1"/>
          <p:nvPr/>
        </p:nvSpPr>
        <p:spPr>
          <a:xfrm>
            <a:off x="771839" y="3901163"/>
            <a:ext cx="97210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miR-93</a:t>
            </a:r>
            <a:endParaRPr lang="en-GB" sz="10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2118391" y="3901163"/>
            <a:ext cx="97210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miR-106b</a:t>
            </a:r>
            <a:endParaRPr lang="en-GB" sz="10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3270142" y="3907346"/>
            <a:ext cx="97210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miR-25</a:t>
            </a:r>
            <a:endParaRPr lang="en-GB" sz="1000" b="1" dirty="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608281" y="6402474"/>
            <a:ext cx="756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gains</a:t>
            </a:r>
            <a:endParaRPr lang="en-GB" sz="1000" b="1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812802" y="6509357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losses</a:t>
            </a:r>
            <a:endParaRPr lang="en-GB" sz="1000" b="1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1083509" y="6496355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No changes</a:t>
            </a:r>
            <a:endParaRPr lang="en-GB" sz="1000" b="1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1862107" y="6407661"/>
            <a:ext cx="756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gains</a:t>
            </a:r>
            <a:endParaRPr lang="en-GB" sz="1000" b="1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2066628" y="6514544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losses</a:t>
            </a:r>
            <a:endParaRPr lang="en-GB" sz="1000" b="1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2337335" y="6501542"/>
            <a:ext cx="9721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No changes</a:t>
            </a:r>
            <a:endParaRPr lang="en-GB" sz="1000" b="1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3060073" y="6455567"/>
            <a:ext cx="8316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gains</a:t>
            </a:r>
            <a:endParaRPr lang="en-GB" sz="1000" b="1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3253792" y="6587653"/>
            <a:ext cx="1069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DNA losses</a:t>
            </a:r>
            <a:endParaRPr lang="en-GB" sz="1000" b="1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3524499" y="6574651"/>
            <a:ext cx="1069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/>
              <a:t>No changes</a:t>
            </a:r>
            <a:endParaRPr lang="en-GB" sz="1000" b="1" dirty="0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-87615" y="5146205"/>
            <a:ext cx="129614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err="1" smtClean="0"/>
              <a:t>miRNA</a:t>
            </a:r>
            <a:r>
              <a:rPr lang="en-GB" sz="1000" b="1" dirty="0" smtClean="0"/>
              <a:t> expression</a:t>
            </a:r>
            <a:endParaRPr lang="en-GB" sz="10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-252536" y="40955"/>
            <a:ext cx="9505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err="1" smtClean="0"/>
              <a:t>miRNA</a:t>
            </a:r>
            <a:r>
              <a:rPr lang="en-GB" b="1" dirty="0" smtClean="0"/>
              <a:t> expression and DNA copy </a:t>
            </a:r>
            <a:r>
              <a:rPr lang="en-GB" b="1" smtClean="0"/>
              <a:t>numbers of miR-17-92 </a:t>
            </a:r>
            <a:r>
              <a:rPr lang="en-GB" b="1" dirty="0" smtClean="0"/>
              <a:t>and mir-106b-25 clusters</a:t>
            </a:r>
            <a:endParaRPr lang="en-GB" b="1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-889393" y="4941733"/>
            <a:ext cx="2148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miR-106b-25</a:t>
            </a:r>
            <a:endParaRPr lang="en-GB" b="1" dirty="0"/>
          </a:p>
        </p:txBody>
      </p:sp>
      <p:sp>
        <p:nvSpPr>
          <p:cNvPr id="54" name="Rectangle 53"/>
          <p:cNvSpPr/>
          <p:nvPr/>
        </p:nvSpPr>
        <p:spPr>
          <a:xfrm>
            <a:off x="1775880" y="4797152"/>
            <a:ext cx="144016" cy="8225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Rectangle 54"/>
          <p:cNvSpPr/>
          <p:nvPr/>
        </p:nvSpPr>
        <p:spPr>
          <a:xfrm>
            <a:off x="3024400" y="4797152"/>
            <a:ext cx="144016" cy="8225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-821378" y="1753391"/>
            <a:ext cx="2148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miR-17-92</a:t>
            </a:r>
            <a:endParaRPr lang="en-GB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7</TotalTime>
  <Words>80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CR-K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CR</dc:creator>
  <cp:lastModifiedBy>Emanuele de Rinaldis</cp:lastModifiedBy>
  <cp:revision>9</cp:revision>
  <dcterms:created xsi:type="dcterms:W3CDTF">2012-05-14T13:22:48Z</dcterms:created>
  <dcterms:modified xsi:type="dcterms:W3CDTF">2013-07-22T17:19:09Z</dcterms:modified>
</cp:coreProperties>
</file>